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3/10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10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test using muscle ultrasound for the identification of children with nephrotic syndrome at risk of malnutrition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5988"/>
            <a:ext cx="1150593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90034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ehad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In children with NS, skeletal muscle ultrasound is a simple and easy-to-use bedside technique for the identification of patients at risk of malnutrition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C07215B-B37B-FD03-F9D5-90CB96F022F7}"/>
              </a:ext>
            </a:extLst>
          </p:cNvPr>
          <p:cNvSpPr txBox="1"/>
          <p:nvPr/>
        </p:nvSpPr>
        <p:spPr>
          <a:xfrm>
            <a:off x="0" y="224082"/>
            <a:ext cx="963827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tility of muscle ultrasound in nutritional assessment of children with nephrotic syndrome</a:t>
            </a:r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B2D4CB6D-1465-79D5-DC65-18A70D81852B}"/>
              </a:ext>
            </a:extLst>
          </p:cNvPr>
          <p:cNvSpPr/>
          <p:nvPr/>
        </p:nvSpPr>
        <p:spPr>
          <a:xfrm>
            <a:off x="752042" y="304749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9BA7322D-4EBA-161D-8A4A-0257917ECDB7}"/>
              </a:ext>
            </a:extLst>
          </p:cNvPr>
          <p:cNvCxnSpPr/>
          <p:nvPr/>
        </p:nvCxnSpPr>
        <p:spPr>
          <a:xfrm flipV="1">
            <a:off x="1437951" y="3011688"/>
            <a:ext cx="613837" cy="40527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D9408F81-9953-EA6C-52B3-9883D8F0114E}"/>
              </a:ext>
            </a:extLst>
          </p:cNvPr>
          <p:cNvCxnSpPr>
            <a:cxnSpLocks/>
          </p:cNvCxnSpPr>
          <p:nvPr/>
        </p:nvCxnSpPr>
        <p:spPr>
          <a:xfrm>
            <a:off x="1429806" y="3945749"/>
            <a:ext cx="414771" cy="59379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CE1D806D-6E1F-DE83-1DC8-4BBED5A59EA4}"/>
              </a:ext>
            </a:extLst>
          </p:cNvPr>
          <p:cNvCxnSpPr/>
          <p:nvPr/>
        </p:nvCxnSpPr>
        <p:spPr>
          <a:xfrm flipV="1">
            <a:off x="1420285" y="3701194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56C803EA-9D5E-AC11-43E2-ECEC0415E581}"/>
              </a:ext>
            </a:extLst>
          </p:cNvPr>
          <p:cNvSpPr/>
          <p:nvPr/>
        </p:nvSpPr>
        <p:spPr>
          <a:xfrm>
            <a:off x="70962" y="301548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8CCEAD7-931D-87C5-2955-2F64B10FF03D}"/>
              </a:ext>
            </a:extLst>
          </p:cNvPr>
          <p:cNvSpPr txBox="1"/>
          <p:nvPr/>
        </p:nvSpPr>
        <p:spPr>
          <a:xfrm>
            <a:off x="101985" y="4229046"/>
            <a:ext cx="1291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case-control study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2B9F915-F3C0-47C8-D38D-D99458B9D425}"/>
              </a:ext>
            </a:extLst>
          </p:cNvPr>
          <p:cNvSpPr txBox="1"/>
          <p:nvPr/>
        </p:nvSpPr>
        <p:spPr>
          <a:xfrm>
            <a:off x="101985" y="2511213"/>
            <a:ext cx="8466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children with NS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671DE1F-7324-6AB5-7F93-8C048AB7AD15}"/>
              </a:ext>
            </a:extLst>
          </p:cNvPr>
          <p:cNvSpPr txBox="1"/>
          <p:nvPr/>
        </p:nvSpPr>
        <p:spPr>
          <a:xfrm>
            <a:off x="877189" y="2511213"/>
            <a:ext cx="8466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matched control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95A24A6E-F7FA-D1A2-FDCC-0E017E909CCC}"/>
              </a:ext>
            </a:extLst>
          </p:cNvPr>
          <p:cNvCxnSpPr/>
          <p:nvPr/>
        </p:nvCxnSpPr>
        <p:spPr>
          <a:xfrm>
            <a:off x="4420015" y="3701194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1F95CFBE-AD56-18A1-731A-2F00DE662E72}"/>
              </a:ext>
            </a:extLst>
          </p:cNvPr>
          <p:cNvSpPr txBox="1"/>
          <p:nvPr/>
        </p:nvSpPr>
        <p:spPr>
          <a:xfrm>
            <a:off x="5839772" y="1850616"/>
            <a:ext cx="2145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ldren with NS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59FDD6B-9292-9DFE-01AA-1C516F7F55EB}"/>
              </a:ext>
            </a:extLst>
          </p:cNvPr>
          <p:cNvSpPr/>
          <p:nvPr/>
        </p:nvSpPr>
        <p:spPr>
          <a:xfrm>
            <a:off x="2410660" y="2259999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mographic, clinical &amp; laboratory data 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E116EC7-7D47-9AEB-3F02-634A59057FF5}"/>
              </a:ext>
            </a:extLst>
          </p:cNvPr>
          <p:cNvSpPr/>
          <p:nvPr/>
        </p:nvSpPr>
        <p:spPr>
          <a:xfrm>
            <a:off x="2410660" y="3391931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-day food intake record</a:t>
            </a:r>
          </a:p>
          <a:p>
            <a:pPr algn="ctr"/>
            <a:endParaRPr lang="en-GB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C650909-8E67-71FC-6F5F-D537059AB039}"/>
              </a:ext>
            </a:extLst>
          </p:cNvPr>
          <p:cNvSpPr/>
          <p:nvPr/>
        </p:nvSpPr>
        <p:spPr>
          <a:xfrm>
            <a:off x="2410659" y="4640547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  <a:p>
            <a:pPr algn="ctr"/>
            <a:r>
              <a:rPr lang="en-GB" dirty="0"/>
              <a:t>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driceps femoris muscle US</a:t>
            </a:r>
          </a:p>
          <a:p>
            <a:pPr algn="ctr"/>
            <a:endParaRPr lang="en-GB" dirty="0"/>
          </a:p>
        </p:txBody>
      </p:sp>
      <p:sp>
        <p:nvSpPr>
          <p:cNvPr id="22" name="Up Arrow 12">
            <a:extLst>
              <a:ext uri="{FF2B5EF4-FFF2-40B4-BE49-F238E27FC236}">
                <a16:creationId xmlns:a16="http://schemas.microsoft.com/office/drawing/2014/main" id="{F53B6F1D-B6C6-45EF-C35B-C33511B86A47}"/>
              </a:ext>
            </a:extLst>
          </p:cNvPr>
          <p:cNvSpPr/>
          <p:nvPr/>
        </p:nvSpPr>
        <p:spPr>
          <a:xfrm rot="10800000">
            <a:off x="5195727" y="2136717"/>
            <a:ext cx="198865" cy="5426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3" name="Up Arrow 12">
            <a:extLst>
              <a:ext uri="{FF2B5EF4-FFF2-40B4-BE49-F238E27FC236}">
                <a16:creationId xmlns:a16="http://schemas.microsoft.com/office/drawing/2014/main" id="{A612B8EA-12AF-06BB-BE8A-6E27BD681B6A}"/>
              </a:ext>
            </a:extLst>
          </p:cNvPr>
          <p:cNvSpPr/>
          <p:nvPr/>
        </p:nvSpPr>
        <p:spPr>
          <a:xfrm>
            <a:off x="5214928" y="3073056"/>
            <a:ext cx="198865" cy="5426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1FEB57-7B41-4DE3-A8E5-88549244F1F8}"/>
              </a:ext>
            </a:extLst>
          </p:cNvPr>
          <p:cNvSpPr txBox="1"/>
          <p:nvPr/>
        </p:nvSpPr>
        <p:spPr>
          <a:xfrm>
            <a:off x="5413793" y="2355040"/>
            <a:ext cx="34220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 measurements of QRFT &amp; QVIT 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F4D9BEE-7F28-5696-26B6-9B47EBEE8F25}"/>
              </a:ext>
            </a:extLst>
          </p:cNvPr>
          <p:cNvSpPr txBox="1"/>
          <p:nvPr/>
        </p:nvSpPr>
        <p:spPr>
          <a:xfrm>
            <a:off x="5413793" y="2997416"/>
            <a:ext cx="29979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intake inadequacy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062BB42-E1C5-BCA4-1421-D6851B2811D0}"/>
              </a:ext>
            </a:extLst>
          </p:cNvPr>
          <p:cNvSpPr txBox="1"/>
          <p:nvPr/>
        </p:nvSpPr>
        <p:spPr>
          <a:xfrm>
            <a:off x="5413793" y="3414898"/>
            <a:ext cx="31631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scle US was significantly independently associated with % of protein intake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91FB43C-2B73-31EB-F9FF-B0269843A76C}"/>
              </a:ext>
            </a:extLst>
          </p:cNvPr>
          <p:cNvSpPr txBox="1"/>
          <p:nvPr/>
        </p:nvSpPr>
        <p:spPr>
          <a:xfrm>
            <a:off x="5413793" y="4495983"/>
            <a:ext cx="316314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C curve revealed the best cutoff of QRFT for the prediction of a patient at risk of malnutrition was 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≤ 1.195 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1842EAC4-ED64-6A00-916F-9CDD04B2DCBE}"/>
              </a:ext>
            </a:extLst>
          </p:cNvPr>
          <p:cNvCxnSpPr/>
          <p:nvPr/>
        </p:nvCxnSpPr>
        <p:spPr>
          <a:xfrm>
            <a:off x="8576933" y="4908913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Picture 32" descr="Chart, line chart&#10;&#10;Description automatically generated">
            <a:extLst>
              <a:ext uri="{FF2B5EF4-FFF2-40B4-BE49-F238E27FC236}">
                <a16:creationId xmlns:a16="http://schemas.microsoft.com/office/drawing/2014/main" id="{5621CD52-1762-C578-DB38-2C042AC393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25051" y="2438695"/>
            <a:ext cx="2597945" cy="2057288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4C95E57B-C0D8-F416-A6E5-E00E9A5EA2A2}"/>
              </a:ext>
            </a:extLst>
          </p:cNvPr>
          <p:cNvSpPr txBox="1"/>
          <p:nvPr/>
        </p:nvSpPr>
        <p:spPr>
          <a:xfrm>
            <a:off x="9382968" y="4539540"/>
            <a:ext cx="280903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C 0.907, sensitivity 86.1%, specificity 77.3%, positive predictive value 75.6%, negative predictive value 87.2% and overall accuracy 81.3% with p &lt;0.001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4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7</cp:revision>
  <dcterms:created xsi:type="dcterms:W3CDTF">2019-06-13T12:30:18Z</dcterms:created>
  <dcterms:modified xsi:type="dcterms:W3CDTF">2022-10-03T23:46:42Z</dcterms:modified>
</cp:coreProperties>
</file>